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5898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4E1FF"/>
    <a:srgbClr val="FF7E79"/>
    <a:srgbClr val="0096FF"/>
    <a:srgbClr val="0432FF"/>
    <a:srgbClr val="008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87"/>
    <p:restoredTop sz="96197"/>
  </p:normalViewPr>
  <p:slideViewPr>
    <p:cSldViewPr snapToGrid="0" snapToObjects="1">
      <p:cViewPr varScale="1">
        <p:scale>
          <a:sx n="81" d="100"/>
          <a:sy n="81" d="100"/>
        </p:scale>
        <p:origin x="29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47F076-C8C0-A741-9885-91F48CDCB025}" type="datetimeFigureOut">
              <a:rPr lang="en-US" smtClean="0"/>
              <a:t>2/24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40C79E-263A-6D45-9FCA-DF56B33AC5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9077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059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065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317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889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7492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962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758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105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656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626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196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487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itle 2">
            <a:extLst>
              <a:ext uri="{FF2B5EF4-FFF2-40B4-BE49-F238E27FC236}">
                <a16:creationId xmlns:a16="http://schemas.microsoft.com/office/drawing/2014/main" id="{C1D89BCE-80C9-49B8-C944-5036C27ED279}"/>
              </a:ext>
            </a:extLst>
          </p:cNvPr>
          <p:cNvSpPr txBox="1">
            <a:spLocks/>
          </p:cNvSpPr>
          <p:nvPr/>
        </p:nvSpPr>
        <p:spPr>
          <a:xfrm>
            <a:off x="102374" y="739835"/>
            <a:ext cx="7670026" cy="31754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785" b="1" dirty="0">
                <a:latin typeface="+mn-lt"/>
                <a:cs typeface="Calibri" panose="020F0502020204030204" pitchFamily="34" charset="0"/>
              </a:rPr>
              <a:t>Spectronaut Visualizations of Zeno SWATH DIA data and Quality Control</a:t>
            </a:r>
            <a:endParaRPr lang="en-US" sz="1785" b="1" dirty="0">
              <a:solidFill>
                <a:srgbClr val="009051"/>
              </a:solidFill>
              <a:latin typeface="+mn-lt"/>
              <a:cs typeface="Calibri" panose="020F0502020204030204" pitchFamily="34" charset="0"/>
            </a:endParaRPr>
          </a:p>
        </p:txBody>
      </p:sp>
      <p:pic>
        <p:nvPicPr>
          <p:cNvPr id="26" name="Picture 25" descr="Chart, scatter chart&#10;&#10;Description automatically generated">
            <a:extLst>
              <a:ext uri="{FF2B5EF4-FFF2-40B4-BE49-F238E27FC236}">
                <a16:creationId xmlns:a16="http://schemas.microsoft.com/office/drawing/2014/main" id="{42263393-B761-AEBA-1947-51B44D9390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045" y="1265475"/>
            <a:ext cx="3308776" cy="1775441"/>
          </a:xfrm>
          <a:prstGeom prst="rect">
            <a:avLst/>
          </a:prstGeom>
        </p:spPr>
      </p:pic>
      <p:pic>
        <p:nvPicPr>
          <p:cNvPr id="27" name="Picture 26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B9494FD4-BAAA-2A4A-BEA0-3B5F09A21E8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231" y="3129497"/>
            <a:ext cx="3230404" cy="1775441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6406551E-EAD0-13F4-EB1D-C92865AA95F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2699" y="3048652"/>
            <a:ext cx="2837143" cy="1826844"/>
          </a:xfrm>
          <a:prstGeom prst="rect">
            <a:avLst/>
          </a:prstGeom>
        </p:spPr>
      </p:pic>
      <p:pic>
        <p:nvPicPr>
          <p:cNvPr id="29" name="Picture 28" descr="Table&#10;&#10;Description automatically generated">
            <a:extLst>
              <a:ext uri="{FF2B5EF4-FFF2-40B4-BE49-F238E27FC236}">
                <a16:creationId xmlns:a16="http://schemas.microsoft.com/office/drawing/2014/main" id="{272435A9-2223-E741-3C4A-D25CB56E422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0751" y="1289666"/>
            <a:ext cx="1921039" cy="1727058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CACD8044-C547-4BC3-8D98-5EF1264E17F9}"/>
              </a:ext>
            </a:extLst>
          </p:cNvPr>
          <p:cNvSpPr txBox="1"/>
          <p:nvPr/>
        </p:nvSpPr>
        <p:spPr>
          <a:xfrm>
            <a:off x="13941" y="1232037"/>
            <a:ext cx="904158" cy="2885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5" dirty="0"/>
              <a:t>Regression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0071702-FC05-815C-60B8-3D8EAFEB424E}"/>
              </a:ext>
            </a:extLst>
          </p:cNvPr>
          <p:cNvSpPr txBox="1"/>
          <p:nvPr/>
        </p:nvSpPr>
        <p:spPr>
          <a:xfrm>
            <a:off x="3903657" y="1265475"/>
            <a:ext cx="1200330" cy="4847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75" dirty="0"/>
              <a:t>Retention Time</a:t>
            </a:r>
          </a:p>
          <a:p>
            <a:pPr algn="ctr"/>
            <a:r>
              <a:rPr lang="en-US" sz="1275" dirty="0" err="1"/>
              <a:t>iRT</a:t>
            </a:r>
            <a:endParaRPr lang="en-US" sz="1275" dirty="0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F634BD17-A3DC-5A24-C2CA-4689DE4983C0}"/>
              </a:ext>
            </a:extLst>
          </p:cNvPr>
          <p:cNvGrpSpPr/>
          <p:nvPr/>
        </p:nvGrpSpPr>
        <p:grpSpPr>
          <a:xfrm>
            <a:off x="5160356" y="2779141"/>
            <a:ext cx="1757176" cy="366320"/>
            <a:chOff x="5160356" y="4988941"/>
            <a:chExt cx="1757176" cy="366320"/>
          </a:xfrm>
        </p:grpSpPr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5CC94981-BBBD-2F7B-05B1-2EE1BD809A01}"/>
                </a:ext>
              </a:extLst>
            </p:cNvPr>
            <p:cNvSpPr/>
            <p:nvPr/>
          </p:nvSpPr>
          <p:spPr>
            <a:xfrm>
              <a:off x="5224131" y="5057552"/>
              <a:ext cx="1657660" cy="2009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0AFE4A6-2DDA-55A4-25C7-B80E71F12C46}"/>
                </a:ext>
              </a:extLst>
            </p:cNvPr>
            <p:cNvSpPr txBox="1"/>
            <p:nvPr/>
          </p:nvSpPr>
          <p:spPr>
            <a:xfrm>
              <a:off x="5848418" y="5093651"/>
              <a:ext cx="4090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Run</a:t>
              </a:r>
            </a:p>
          </p:txBody>
        </p: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A599D982-478F-0A7D-2F9F-FE2F6CA8132D}"/>
                </a:ext>
              </a:extLst>
            </p:cNvPr>
            <p:cNvGrpSpPr/>
            <p:nvPr/>
          </p:nvGrpSpPr>
          <p:grpSpPr>
            <a:xfrm>
              <a:off x="5160356" y="4988941"/>
              <a:ext cx="1757176" cy="215444"/>
              <a:chOff x="5160356" y="4988941"/>
              <a:chExt cx="1757176" cy="215444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E2CCC9F3-AE3C-F822-9090-7C6EC71A124A}"/>
                  </a:ext>
                </a:extLst>
              </p:cNvPr>
              <p:cNvSpPr txBox="1"/>
              <p:nvPr/>
            </p:nvSpPr>
            <p:spPr>
              <a:xfrm>
                <a:off x="5160356" y="498894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1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73A1E5E0-0547-A151-1C37-782C70C9A5B0}"/>
                  </a:ext>
                </a:extLst>
              </p:cNvPr>
              <p:cNvSpPr txBox="1"/>
              <p:nvPr/>
            </p:nvSpPr>
            <p:spPr>
              <a:xfrm>
                <a:off x="5376548" y="498894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2C9CA0A8-5648-1B5B-1D5E-297043C638C7}"/>
                  </a:ext>
                </a:extLst>
              </p:cNvPr>
              <p:cNvSpPr txBox="1"/>
              <p:nvPr/>
            </p:nvSpPr>
            <p:spPr>
              <a:xfrm>
                <a:off x="5599829" y="498894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3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2EC06F96-4A8E-90DF-7887-79D7BC1A0CDD}"/>
                  </a:ext>
                </a:extLst>
              </p:cNvPr>
              <p:cNvSpPr txBox="1"/>
              <p:nvPr/>
            </p:nvSpPr>
            <p:spPr>
              <a:xfrm>
                <a:off x="5808935" y="498894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4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4AE13E8-70E5-54D2-A21C-F890B6CD93A3}"/>
                  </a:ext>
                </a:extLst>
              </p:cNvPr>
              <p:cNvSpPr txBox="1"/>
              <p:nvPr/>
            </p:nvSpPr>
            <p:spPr>
              <a:xfrm>
                <a:off x="6032451" y="498894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5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F730B454-7BC6-D252-05C4-D00559B5EDD4}"/>
                  </a:ext>
                </a:extLst>
              </p:cNvPr>
              <p:cNvSpPr txBox="1"/>
              <p:nvPr/>
            </p:nvSpPr>
            <p:spPr>
              <a:xfrm>
                <a:off x="6249184" y="498894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6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5F739954-19EE-77F3-7761-AFE1C500A2A9}"/>
                  </a:ext>
                </a:extLst>
              </p:cNvPr>
              <p:cNvSpPr txBox="1"/>
              <p:nvPr/>
            </p:nvSpPr>
            <p:spPr>
              <a:xfrm>
                <a:off x="6472466" y="498894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7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95EEF4D4-D4A5-9B3F-85A9-10CDC7BC161B}"/>
                  </a:ext>
                </a:extLst>
              </p:cNvPr>
              <p:cNvSpPr txBox="1"/>
              <p:nvPr/>
            </p:nvSpPr>
            <p:spPr>
              <a:xfrm>
                <a:off x="6681570" y="498894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8</a:t>
                </a:r>
              </a:p>
            </p:txBody>
          </p:sp>
        </p:grpSp>
      </p:grpSp>
      <p:sp>
        <p:nvSpPr>
          <p:cNvPr id="34" name="Rectangle 33">
            <a:extLst>
              <a:ext uri="{FF2B5EF4-FFF2-40B4-BE49-F238E27FC236}">
                <a16:creationId xmlns:a16="http://schemas.microsoft.com/office/drawing/2014/main" id="{62244075-6CFF-4A65-B757-085606C7B08B}"/>
              </a:ext>
            </a:extLst>
          </p:cNvPr>
          <p:cNvSpPr/>
          <p:nvPr/>
        </p:nvSpPr>
        <p:spPr>
          <a:xfrm>
            <a:off x="4960751" y="1575391"/>
            <a:ext cx="263380" cy="127236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44A7632-CF36-CF55-28F3-175BB586E696}"/>
              </a:ext>
            </a:extLst>
          </p:cNvPr>
          <p:cNvSpPr txBox="1"/>
          <p:nvPr/>
        </p:nvSpPr>
        <p:spPr>
          <a:xfrm>
            <a:off x="4968756" y="152766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dirty="0"/>
              <a:t>12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F283E60-EAA4-64DA-5D3E-45F858047FEC}"/>
              </a:ext>
            </a:extLst>
          </p:cNvPr>
          <p:cNvSpPr txBox="1"/>
          <p:nvPr/>
        </p:nvSpPr>
        <p:spPr>
          <a:xfrm>
            <a:off x="4968757" y="1784745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8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57ED7B3-BFD3-9285-E94C-DE0E1508553B}"/>
              </a:ext>
            </a:extLst>
          </p:cNvPr>
          <p:cNvSpPr txBox="1"/>
          <p:nvPr/>
        </p:nvSpPr>
        <p:spPr>
          <a:xfrm>
            <a:off x="4968757" y="2045268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4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90E96BA-12E8-2F4B-5CF8-DF6C595B5B3F}"/>
              </a:ext>
            </a:extLst>
          </p:cNvPr>
          <p:cNvSpPr txBox="1"/>
          <p:nvPr/>
        </p:nvSpPr>
        <p:spPr>
          <a:xfrm>
            <a:off x="4968757" y="2303587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43424D7-06C9-8092-F1F0-953BA901AC48}"/>
              </a:ext>
            </a:extLst>
          </p:cNvPr>
          <p:cNvSpPr txBox="1"/>
          <p:nvPr/>
        </p:nvSpPr>
        <p:spPr>
          <a:xfrm>
            <a:off x="4968757" y="2566266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-4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209D8E3-CDD8-2CFA-97D3-E84E0F21256E}"/>
              </a:ext>
            </a:extLst>
          </p:cNvPr>
          <p:cNvSpPr txBox="1"/>
          <p:nvPr/>
        </p:nvSpPr>
        <p:spPr>
          <a:xfrm rot="16200000">
            <a:off x="4774481" y="2077349"/>
            <a:ext cx="35458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/>
              <a:t>iRT</a:t>
            </a:r>
            <a:endParaRPr lang="en-US" sz="1050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FE1B6E39-D12E-1F0F-0ED0-285A1969C4F7}"/>
              </a:ext>
            </a:extLst>
          </p:cNvPr>
          <p:cNvSpPr/>
          <p:nvPr/>
        </p:nvSpPr>
        <p:spPr>
          <a:xfrm>
            <a:off x="466020" y="1475672"/>
            <a:ext cx="363320" cy="13858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477163E-5B59-0461-0458-261E6B708F46}"/>
              </a:ext>
            </a:extLst>
          </p:cNvPr>
          <p:cNvSpPr txBox="1"/>
          <p:nvPr/>
        </p:nvSpPr>
        <p:spPr>
          <a:xfrm>
            <a:off x="583066" y="159859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dirty="0"/>
              <a:t>12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5D9F2B8-3061-BE05-E8FC-CEEE1AC96991}"/>
              </a:ext>
            </a:extLst>
          </p:cNvPr>
          <p:cNvSpPr txBox="1"/>
          <p:nvPr/>
        </p:nvSpPr>
        <p:spPr>
          <a:xfrm>
            <a:off x="583067" y="1793524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10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2EC7B2C-61BF-936E-C8D8-4F1B6253E0D5}"/>
              </a:ext>
            </a:extLst>
          </p:cNvPr>
          <p:cNvSpPr txBox="1"/>
          <p:nvPr/>
        </p:nvSpPr>
        <p:spPr>
          <a:xfrm>
            <a:off x="583067" y="1976174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8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6C32F34-6A11-70A0-962E-A5980347773A}"/>
              </a:ext>
            </a:extLst>
          </p:cNvPr>
          <p:cNvSpPr txBox="1"/>
          <p:nvPr/>
        </p:nvSpPr>
        <p:spPr>
          <a:xfrm>
            <a:off x="583067" y="2162205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6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568AC51-78F4-5DBE-906F-8DA31260E335}"/>
              </a:ext>
            </a:extLst>
          </p:cNvPr>
          <p:cNvSpPr txBox="1"/>
          <p:nvPr/>
        </p:nvSpPr>
        <p:spPr>
          <a:xfrm>
            <a:off x="583067" y="2343023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4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F30BA7F-A5AD-D648-87E7-D99CBF018B25}"/>
              </a:ext>
            </a:extLst>
          </p:cNvPr>
          <p:cNvSpPr txBox="1"/>
          <p:nvPr/>
        </p:nvSpPr>
        <p:spPr>
          <a:xfrm>
            <a:off x="583067" y="2526911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2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23D8801-74DA-1DAE-CFD7-4026809DB8AA}"/>
              </a:ext>
            </a:extLst>
          </p:cNvPr>
          <p:cNvSpPr txBox="1"/>
          <p:nvPr/>
        </p:nvSpPr>
        <p:spPr>
          <a:xfrm rot="16200000">
            <a:off x="52963" y="2041953"/>
            <a:ext cx="10262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Retention Tim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BDFC9BD-40AD-F66A-3446-50E000133B59}"/>
              </a:ext>
            </a:extLst>
          </p:cNvPr>
          <p:cNvSpPr txBox="1"/>
          <p:nvPr/>
        </p:nvSpPr>
        <p:spPr>
          <a:xfrm>
            <a:off x="583334" y="1425135"/>
            <a:ext cx="3385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dirty="0"/>
              <a:t>14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CDC2988-0DD4-F779-C150-69556041F3FE}"/>
              </a:ext>
            </a:extLst>
          </p:cNvPr>
          <p:cNvSpPr txBox="1"/>
          <p:nvPr/>
        </p:nvSpPr>
        <p:spPr>
          <a:xfrm>
            <a:off x="583425" y="2711352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0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DBF4BAAA-ACE9-DFAE-63A4-21892E45FC7C}"/>
              </a:ext>
            </a:extLst>
          </p:cNvPr>
          <p:cNvSpPr/>
          <p:nvPr/>
        </p:nvSpPr>
        <p:spPr>
          <a:xfrm>
            <a:off x="693043" y="2883851"/>
            <a:ext cx="3158778" cy="1648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FB1EBFA-5512-E7C3-BE68-D369286EBD77}"/>
              </a:ext>
            </a:extLst>
          </p:cNvPr>
          <p:cNvSpPr txBox="1"/>
          <p:nvPr/>
        </p:nvSpPr>
        <p:spPr>
          <a:xfrm>
            <a:off x="13941" y="2914240"/>
            <a:ext cx="1123000" cy="2885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5" dirty="0"/>
              <a:t>Completenes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2CF2027-B1A8-359C-75B5-C3FDE271C459}"/>
              </a:ext>
            </a:extLst>
          </p:cNvPr>
          <p:cNvSpPr txBox="1"/>
          <p:nvPr/>
        </p:nvSpPr>
        <p:spPr>
          <a:xfrm>
            <a:off x="2623081" y="2796805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10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B9F5A08-14F4-A6B3-7E96-253B6A6C89FC}"/>
              </a:ext>
            </a:extLst>
          </p:cNvPr>
          <p:cNvSpPr txBox="1"/>
          <p:nvPr/>
        </p:nvSpPr>
        <p:spPr>
          <a:xfrm>
            <a:off x="3099355" y="2796805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15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ADD4B9E-F798-D100-AA92-A05BF60B0540}"/>
              </a:ext>
            </a:extLst>
          </p:cNvPr>
          <p:cNvSpPr txBox="1"/>
          <p:nvPr/>
        </p:nvSpPr>
        <p:spPr>
          <a:xfrm>
            <a:off x="3590535" y="2796805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20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6538BFC-E1BA-11D1-B659-07151CE3BA90}"/>
              </a:ext>
            </a:extLst>
          </p:cNvPr>
          <p:cNvSpPr txBox="1"/>
          <p:nvPr/>
        </p:nvSpPr>
        <p:spPr>
          <a:xfrm>
            <a:off x="2147503" y="2796805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9820DC7-29A1-8E8C-7319-BD4A6536602C}"/>
              </a:ext>
            </a:extLst>
          </p:cNvPr>
          <p:cNvSpPr txBox="1"/>
          <p:nvPr/>
        </p:nvSpPr>
        <p:spPr>
          <a:xfrm>
            <a:off x="1656585" y="2796805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DFDF7DC-A49B-4C31-DE81-9E7D98F41803}"/>
              </a:ext>
            </a:extLst>
          </p:cNvPr>
          <p:cNvSpPr txBox="1"/>
          <p:nvPr/>
        </p:nvSpPr>
        <p:spPr>
          <a:xfrm>
            <a:off x="1184127" y="2796805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-5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30D389D-D529-A366-7AAF-0971D35E5FE3}"/>
              </a:ext>
            </a:extLst>
          </p:cNvPr>
          <p:cNvSpPr txBox="1"/>
          <p:nvPr/>
        </p:nvSpPr>
        <p:spPr>
          <a:xfrm>
            <a:off x="677729" y="2796805"/>
            <a:ext cx="3954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-10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B0AD53C-C32C-A777-B28D-D01D6AE9DB6F}"/>
              </a:ext>
            </a:extLst>
          </p:cNvPr>
          <p:cNvSpPr txBox="1"/>
          <p:nvPr/>
        </p:nvSpPr>
        <p:spPr>
          <a:xfrm>
            <a:off x="2134067" y="2888969"/>
            <a:ext cx="35458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/>
              <a:t>iRT</a:t>
            </a:r>
            <a:endParaRPr lang="en-US" sz="1050" dirty="0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B6970AD7-2F0F-72A9-17A8-A7E7D123BE27}"/>
              </a:ext>
            </a:extLst>
          </p:cNvPr>
          <p:cNvSpPr/>
          <p:nvPr/>
        </p:nvSpPr>
        <p:spPr>
          <a:xfrm>
            <a:off x="845397" y="4559595"/>
            <a:ext cx="2883087" cy="3453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B6A1D1C-E713-5872-3303-5E57BA589B64}"/>
              </a:ext>
            </a:extLst>
          </p:cNvPr>
          <p:cNvSpPr txBox="1"/>
          <p:nvPr/>
        </p:nvSpPr>
        <p:spPr>
          <a:xfrm rot="18891367">
            <a:off x="663548" y="4573863"/>
            <a:ext cx="5016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Non.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546AD10-4CE3-FF95-629A-0A6F251BCC73}"/>
              </a:ext>
            </a:extLst>
          </p:cNvPr>
          <p:cNvSpPr txBox="1"/>
          <p:nvPr/>
        </p:nvSpPr>
        <p:spPr>
          <a:xfrm rot="18891367">
            <a:off x="1042771" y="4577407"/>
            <a:ext cx="5016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Inj.1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2AC2782F-72B5-7335-7C77-7B4CC5A778E6}"/>
              </a:ext>
            </a:extLst>
          </p:cNvPr>
          <p:cNvSpPr txBox="1"/>
          <p:nvPr/>
        </p:nvSpPr>
        <p:spPr>
          <a:xfrm rot="18891367">
            <a:off x="1407823" y="4580954"/>
            <a:ext cx="5016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Non.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BAAC747-60CB-CD71-40B9-D0E4B25DF4FC}"/>
              </a:ext>
            </a:extLst>
          </p:cNvPr>
          <p:cNvSpPr txBox="1"/>
          <p:nvPr/>
        </p:nvSpPr>
        <p:spPr>
          <a:xfrm rot="18891367">
            <a:off x="1772874" y="4591583"/>
            <a:ext cx="5016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Inj.2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5910E78-E1E1-EFBD-F356-0714ED90FB9A}"/>
              </a:ext>
            </a:extLst>
          </p:cNvPr>
          <p:cNvSpPr txBox="1"/>
          <p:nvPr/>
        </p:nvSpPr>
        <p:spPr>
          <a:xfrm rot="18891367">
            <a:off x="2137925" y="4602218"/>
            <a:ext cx="5016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Non.3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B31C253-2BD6-835A-0142-EC6C9B505FF3}"/>
              </a:ext>
            </a:extLst>
          </p:cNvPr>
          <p:cNvSpPr txBox="1"/>
          <p:nvPr/>
        </p:nvSpPr>
        <p:spPr>
          <a:xfrm rot="18891367">
            <a:off x="2502975" y="4598671"/>
            <a:ext cx="5016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Non.4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F79446F-BD39-9179-A14F-9BAC1C82D417}"/>
              </a:ext>
            </a:extLst>
          </p:cNvPr>
          <p:cNvSpPr txBox="1"/>
          <p:nvPr/>
        </p:nvSpPr>
        <p:spPr>
          <a:xfrm rot="18891367">
            <a:off x="2868030" y="4602213"/>
            <a:ext cx="5016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Inj.3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D6D4ED0-F1C7-8AFA-3D72-B164DC2343D9}"/>
              </a:ext>
            </a:extLst>
          </p:cNvPr>
          <p:cNvSpPr txBox="1"/>
          <p:nvPr/>
        </p:nvSpPr>
        <p:spPr>
          <a:xfrm rot="18891367">
            <a:off x="3233085" y="4598671"/>
            <a:ext cx="5016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Inj.4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1A3D5BA-D486-36A1-BA1F-0CE1538D0295}"/>
              </a:ext>
            </a:extLst>
          </p:cNvPr>
          <p:cNvSpPr txBox="1"/>
          <p:nvPr/>
        </p:nvSpPr>
        <p:spPr>
          <a:xfrm>
            <a:off x="2067889" y="4751645"/>
            <a:ext cx="4090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Run</a:t>
            </a: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9688CEF7-9379-1446-548B-42A929C66CAA}"/>
              </a:ext>
            </a:extLst>
          </p:cNvPr>
          <p:cNvSpPr/>
          <p:nvPr/>
        </p:nvSpPr>
        <p:spPr>
          <a:xfrm>
            <a:off x="575441" y="3273124"/>
            <a:ext cx="213023" cy="12864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30D78F6-4153-2713-F8FC-A1C93A12311E}"/>
              </a:ext>
            </a:extLst>
          </p:cNvPr>
          <p:cNvSpPr txBox="1"/>
          <p:nvPr/>
        </p:nvSpPr>
        <p:spPr>
          <a:xfrm>
            <a:off x="557078" y="3925701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2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F090A86-0DD7-51AF-4A07-603D5D08CF5F}"/>
              </a:ext>
            </a:extLst>
          </p:cNvPr>
          <p:cNvSpPr txBox="1"/>
          <p:nvPr/>
        </p:nvSpPr>
        <p:spPr>
          <a:xfrm>
            <a:off x="557078" y="4157229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1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DE095DB-21C0-20A2-FB84-168A2F1E4066}"/>
              </a:ext>
            </a:extLst>
          </p:cNvPr>
          <p:cNvSpPr txBox="1"/>
          <p:nvPr/>
        </p:nvSpPr>
        <p:spPr>
          <a:xfrm>
            <a:off x="557078" y="4402441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D4F0F95-0A8B-FE56-3549-4548B1747D41}"/>
              </a:ext>
            </a:extLst>
          </p:cNvPr>
          <p:cNvSpPr txBox="1"/>
          <p:nvPr/>
        </p:nvSpPr>
        <p:spPr>
          <a:xfrm>
            <a:off x="557078" y="3686906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3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AA22A5DB-FA1B-2E74-19A3-034071576555}"/>
              </a:ext>
            </a:extLst>
          </p:cNvPr>
          <p:cNvSpPr txBox="1"/>
          <p:nvPr/>
        </p:nvSpPr>
        <p:spPr>
          <a:xfrm>
            <a:off x="557078" y="3449768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4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016085D-140D-6C99-9FDE-A2D416ADCE95}"/>
              </a:ext>
            </a:extLst>
          </p:cNvPr>
          <p:cNvSpPr txBox="1"/>
          <p:nvPr/>
        </p:nvSpPr>
        <p:spPr>
          <a:xfrm>
            <a:off x="557078" y="3221840"/>
            <a:ext cx="338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5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AA781CE-5102-23AE-85A4-850413F7ED2D}"/>
              </a:ext>
            </a:extLst>
          </p:cNvPr>
          <p:cNvSpPr txBox="1"/>
          <p:nvPr/>
        </p:nvSpPr>
        <p:spPr>
          <a:xfrm rot="16200000">
            <a:off x="-162247" y="3782155"/>
            <a:ext cx="150874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Nr. Of Precursors (10^3)</a:t>
            </a:r>
          </a:p>
        </p:txBody>
      </p:sp>
      <p:grpSp>
        <p:nvGrpSpPr>
          <p:cNvPr id="88" name="Group 87">
            <a:extLst>
              <a:ext uri="{FF2B5EF4-FFF2-40B4-BE49-F238E27FC236}">
                <a16:creationId xmlns:a16="http://schemas.microsoft.com/office/drawing/2014/main" id="{8DC90802-77EE-07A0-9C40-0C068F21ED11}"/>
              </a:ext>
            </a:extLst>
          </p:cNvPr>
          <p:cNvGrpSpPr/>
          <p:nvPr/>
        </p:nvGrpSpPr>
        <p:grpSpPr>
          <a:xfrm>
            <a:off x="4749149" y="4612253"/>
            <a:ext cx="2640019" cy="373334"/>
            <a:chOff x="4669216" y="7741244"/>
            <a:chExt cx="2640019" cy="373334"/>
          </a:xfrm>
        </p:grpSpPr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3530FEEC-E0A6-23C4-229E-5CA679A7DF56}"/>
                </a:ext>
              </a:extLst>
            </p:cNvPr>
            <p:cNvGrpSpPr/>
            <p:nvPr/>
          </p:nvGrpSpPr>
          <p:grpSpPr>
            <a:xfrm>
              <a:off x="4669216" y="7741244"/>
              <a:ext cx="2611667" cy="373334"/>
              <a:chOff x="4905178" y="4981145"/>
              <a:chExt cx="2611667" cy="373334"/>
            </a:xfrm>
          </p:grpSpPr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E3780D46-51F2-2A59-E406-D3A39592CA51}"/>
                  </a:ext>
                </a:extLst>
              </p:cNvPr>
              <p:cNvSpPr/>
              <p:nvPr/>
            </p:nvSpPr>
            <p:spPr>
              <a:xfrm>
                <a:off x="4946991" y="5057552"/>
                <a:ext cx="2569854" cy="2009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83685D25-9A20-44CF-C257-4440E150ABD5}"/>
                  </a:ext>
                </a:extLst>
              </p:cNvPr>
              <p:cNvSpPr txBox="1"/>
              <p:nvPr/>
            </p:nvSpPr>
            <p:spPr>
              <a:xfrm>
                <a:off x="5517552" y="5100563"/>
                <a:ext cx="140775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rotein Group </a:t>
                </a:r>
                <a:r>
                  <a:rPr lang="en-US" sz="1050" dirty="0" err="1"/>
                  <a:t>Cscores</a:t>
                </a:r>
                <a:endParaRPr lang="en-US" sz="1050" dirty="0"/>
              </a:p>
            </p:txBody>
          </p:sp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29DB3449-F9FB-A927-80B8-9D3DE46222BC}"/>
                  </a:ext>
                </a:extLst>
              </p:cNvPr>
              <p:cNvGrpSpPr/>
              <p:nvPr/>
            </p:nvGrpSpPr>
            <p:grpSpPr>
              <a:xfrm>
                <a:off x="4905178" y="4981145"/>
                <a:ext cx="1943149" cy="215444"/>
                <a:chOff x="4905178" y="4981145"/>
                <a:chExt cx="1943149" cy="215444"/>
              </a:xfrm>
            </p:grpSpPr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8911EA24-2C5E-6E8D-AC15-CF4DA32DA106}"/>
                    </a:ext>
                  </a:extLst>
                </p:cNvPr>
                <p:cNvSpPr txBox="1"/>
                <p:nvPr/>
              </p:nvSpPr>
              <p:spPr>
                <a:xfrm>
                  <a:off x="4905178" y="4981145"/>
                  <a:ext cx="31931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-40</a:t>
                  </a: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6221F76F-2E0F-3A2C-BF9B-E9724D04E670}"/>
                    </a:ext>
                  </a:extLst>
                </p:cNvPr>
                <p:cNvSpPr txBox="1"/>
                <p:nvPr/>
              </p:nvSpPr>
              <p:spPr>
                <a:xfrm>
                  <a:off x="5135547" y="4981145"/>
                  <a:ext cx="31931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-30</a:t>
                  </a: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857EEA53-A2D4-8E7F-EF0C-6E37DD6684C5}"/>
                    </a:ext>
                  </a:extLst>
                </p:cNvPr>
                <p:cNvSpPr txBox="1"/>
                <p:nvPr/>
              </p:nvSpPr>
              <p:spPr>
                <a:xfrm>
                  <a:off x="5373005" y="4981145"/>
                  <a:ext cx="31931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-20</a:t>
                  </a:r>
                </a:p>
              </p:txBody>
            </p: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0F603229-C548-EF85-2DC9-76E51BF5EDBA}"/>
                    </a:ext>
                  </a:extLst>
                </p:cNvPr>
                <p:cNvSpPr txBox="1"/>
                <p:nvPr/>
              </p:nvSpPr>
              <p:spPr>
                <a:xfrm>
                  <a:off x="5603376" y="4981145"/>
                  <a:ext cx="31931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-10</a:t>
                  </a:r>
                </a:p>
              </p:txBody>
            </p: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944A5678-A109-541D-4CBD-25D3DC72F8AB}"/>
                    </a:ext>
                  </a:extLst>
                </p:cNvPr>
                <p:cNvSpPr txBox="1"/>
                <p:nvPr/>
              </p:nvSpPr>
              <p:spPr>
                <a:xfrm>
                  <a:off x="5883598" y="4981145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0</a:t>
                  </a:r>
                </a:p>
              </p:txBody>
            </p:sp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id="{7273C6E6-532D-B366-87EB-8A51292845F4}"/>
                    </a:ext>
                  </a:extLst>
                </p:cNvPr>
                <p:cNvSpPr txBox="1"/>
                <p:nvPr/>
              </p:nvSpPr>
              <p:spPr>
                <a:xfrm>
                  <a:off x="6093242" y="4981145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10</a:t>
                  </a:r>
                </a:p>
              </p:txBody>
            </p: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CCB7F567-88FF-AF8A-F3F7-02F0007A1C02}"/>
                    </a:ext>
                  </a:extLst>
                </p:cNvPr>
                <p:cNvSpPr txBox="1"/>
                <p:nvPr/>
              </p:nvSpPr>
              <p:spPr>
                <a:xfrm>
                  <a:off x="6323614" y="4981145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20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2D878F24-E94A-906A-5899-22381B4E4ED4}"/>
                    </a:ext>
                  </a:extLst>
                </p:cNvPr>
                <p:cNvSpPr txBox="1"/>
                <p:nvPr/>
              </p:nvSpPr>
              <p:spPr>
                <a:xfrm>
                  <a:off x="6561069" y="4981145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30</a:t>
                  </a:r>
                </a:p>
              </p:txBody>
            </p:sp>
          </p:grpSp>
        </p:grp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D533A4CC-D074-575C-9DDA-EE754DF24594}"/>
                </a:ext>
              </a:extLst>
            </p:cNvPr>
            <p:cNvSpPr txBox="1"/>
            <p:nvPr/>
          </p:nvSpPr>
          <p:spPr>
            <a:xfrm>
              <a:off x="6557400" y="774124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0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B04D49D1-6420-3AA1-F150-E7372987C993}"/>
                </a:ext>
              </a:extLst>
            </p:cNvPr>
            <p:cNvSpPr txBox="1"/>
            <p:nvPr/>
          </p:nvSpPr>
          <p:spPr>
            <a:xfrm>
              <a:off x="6784520" y="774124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0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A1B91185-4CCD-878C-CACA-A5FB3924E9B7}"/>
                </a:ext>
              </a:extLst>
            </p:cNvPr>
            <p:cNvSpPr txBox="1"/>
            <p:nvPr/>
          </p:nvSpPr>
          <p:spPr>
            <a:xfrm>
              <a:off x="7021977" y="774124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60</a:t>
              </a:r>
            </a:p>
          </p:txBody>
        </p:sp>
      </p:grpSp>
      <p:sp>
        <p:nvSpPr>
          <p:cNvPr id="99" name="Rectangle 98">
            <a:extLst>
              <a:ext uri="{FF2B5EF4-FFF2-40B4-BE49-F238E27FC236}">
                <a16:creationId xmlns:a16="http://schemas.microsoft.com/office/drawing/2014/main" id="{C0DCC438-8269-3895-B30F-CE3125E7391C}"/>
              </a:ext>
            </a:extLst>
          </p:cNvPr>
          <p:cNvSpPr/>
          <p:nvPr/>
        </p:nvSpPr>
        <p:spPr>
          <a:xfrm>
            <a:off x="4502699" y="3202781"/>
            <a:ext cx="288263" cy="14607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B3EB3CD-40D4-5459-1112-F25DE50AD90A}"/>
              </a:ext>
            </a:extLst>
          </p:cNvPr>
          <p:cNvSpPr txBox="1"/>
          <p:nvPr/>
        </p:nvSpPr>
        <p:spPr>
          <a:xfrm>
            <a:off x="4538624" y="3184867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dirty="0"/>
              <a:t>0.08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C53FEC2-BF96-6D3E-0745-C8D4D011F857}"/>
              </a:ext>
            </a:extLst>
          </p:cNvPr>
          <p:cNvSpPr txBox="1"/>
          <p:nvPr/>
        </p:nvSpPr>
        <p:spPr>
          <a:xfrm>
            <a:off x="4538624" y="3518019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dirty="0"/>
              <a:t>0.06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D327CE4-78B3-CDF0-49B7-38CB4AFA68FC}"/>
              </a:ext>
            </a:extLst>
          </p:cNvPr>
          <p:cNvSpPr txBox="1"/>
          <p:nvPr/>
        </p:nvSpPr>
        <p:spPr>
          <a:xfrm>
            <a:off x="4538624" y="3844084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dirty="0"/>
              <a:t>0.04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925F0E14-5303-3E74-4C29-890599A14ADC}"/>
              </a:ext>
            </a:extLst>
          </p:cNvPr>
          <p:cNvSpPr txBox="1"/>
          <p:nvPr/>
        </p:nvSpPr>
        <p:spPr>
          <a:xfrm>
            <a:off x="4538624" y="4184325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dirty="0"/>
              <a:t>0.02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E910135E-A07B-9A4D-7B57-04924B0D77AB}"/>
              </a:ext>
            </a:extLst>
          </p:cNvPr>
          <p:cNvSpPr txBox="1"/>
          <p:nvPr/>
        </p:nvSpPr>
        <p:spPr>
          <a:xfrm>
            <a:off x="4538624" y="4517478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dirty="0"/>
              <a:t>0.0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717187F-FB2E-0431-1F93-B080D4864D71}"/>
              </a:ext>
            </a:extLst>
          </p:cNvPr>
          <p:cNvSpPr txBox="1"/>
          <p:nvPr/>
        </p:nvSpPr>
        <p:spPr>
          <a:xfrm>
            <a:off x="3931884" y="2947678"/>
            <a:ext cx="777009" cy="4847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75" dirty="0"/>
              <a:t>Searches</a:t>
            </a:r>
          </a:p>
          <a:p>
            <a:pPr algn="ctr"/>
            <a:r>
              <a:rPr lang="en-US" sz="1275" dirty="0"/>
              <a:t>Q values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25181806-D789-C609-BE45-9EFF8934E37D}"/>
              </a:ext>
            </a:extLst>
          </p:cNvPr>
          <p:cNvSpPr txBox="1"/>
          <p:nvPr/>
        </p:nvSpPr>
        <p:spPr>
          <a:xfrm rot="16200000">
            <a:off x="4124541" y="3854455"/>
            <a:ext cx="75854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Frequency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94336F6-8087-6C3F-DFDC-311374AD6553}"/>
              </a:ext>
            </a:extLst>
          </p:cNvPr>
          <p:cNvSpPr txBox="1"/>
          <p:nvPr/>
        </p:nvSpPr>
        <p:spPr>
          <a:xfrm>
            <a:off x="439126" y="365760"/>
            <a:ext cx="1228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-0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9D3DABB-2B66-30DC-A6CB-9C5622B72914}"/>
              </a:ext>
            </a:extLst>
          </p:cNvPr>
          <p:cNvSpPr txBox="1"/>
          <p:nvPr/>
        </p:nvSpPr>
        <p:spPr>
          <a:xfrm>
            <a:off x="400689" y="7157896"/>
            <a:ext cx="7005936" cy="25351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5 Fig. Quality assessment of DIA data collected with a 120-min microflow gradient.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pectronaut 16 generated plots for retention time calibration, </a:t>
            </a:r>
            <a:r>
              <a:rPr lang="en-US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RT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peptide retention times, data completeness, and q-values of identifications demonstrate the robustness of the DIA data acquired with 80 variable windows using a 120-min microflow chromatography gradient.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53372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1" grpId="0"/>
      <p:bldP spid="32" grpId="0"/>
      <p:bldP spid="33" grpId="0"/>
    </p:bld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40</TotalTime>
  <Words>173</Words>
  <Application>Microsoft Macintosh PowerPoint</Application>
  <PresentationFormat>Custom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in Figures</dc:title>
  <dc:creator>Jordan Burton</dc:creator>
  <cp:lastModifiedBy>Jordan Burton</cp:lastModifiedBy>
  <cp:revision>40</cp:revision>
  <cp:lastPrinted>2022-06-23T21:58:45Z</cp:lastPrinted>
  <dcterms:created xsi:type="dcterms:W3CDTF">2022-06-13T21:49:24Z</dcterms:created>
  <dcterms:modified xsi:type="dcterms:W3CDTF">2023-02-25T01:04:27Z</dcterms:modified>
</cp:coreProperties>
</file>